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4" r:id="rId2"/>
    <p:sldId id="266" r:id="rId3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4" autoAdjust="0"/>
    <p:restoredTop sz="94660"/>
  </p:normalViewPr>
  <p:slideViewPr>
    <p:cSldViewPr snapToGrid="0">
      <p:cViewPr>
        <p:scale>
          <a:sx n="80" d="100"/>
          <a:sy n="80" d="100"/>
        </p:scale>
        <p:origin x="2214" y="-3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9760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777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1993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415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402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6422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091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7667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2450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8014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8656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8C90B-CA1E-4AD0-B2DD-B163D5627639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FC1EB0-65C9-4C42-8D52-732294EBE1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4085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g"/><Relationship Id="rId3" Type="http://schemas.openxmlformats.org/officeDocument/2006/relationships/image" Target="../media/image5.png"/><Relationship Id="rId7" Type="http://schemas.microsoft.com/office/2007/relationships/hdphoto" Target="../media/hdphoto2.wdp"/><Relationship Id="rId12" Type="http://schemas.openxmlformats.org/officeDocument/2006/relationships/image" Target="../media/image11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0.jpg"/><Relationship Id="rId5" Type="http://schemas.openxmlformats.org/officeDocument/2006/relationships/image" Target="../media/image6.jpg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18ED4B7-CCC7-B25C-8F81-E19A3689482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27AFF34-7B92-3CE1-3AC0-031CADC7402C}"/>
              </a:ext>
            </a:extLst>
          </p:cNvPr>
          <p:cNvSpPr txBox="1"/>
          <p:nvPr/>
        </p:nvSpPr>
        <p:spPr>
          <a:xfrm>
            <a:off x="-15519" y="1"/>
            <a:ext cx="2364750" cy="399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999" i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ja-JP" altLang="en-US" sz="1999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999" i="1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lang="ja-JP" altLang="en-US" sz="1999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1C4F3706-D050-054B-CD2F-BA9E1BEDC2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867" y="1242671"/>
            <a:ext cx="4688733" cy="3530339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E4EAF079-41C4-C466-3A2E-9F07F6D9DE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3829" y="1240616"/>
            <a:ext cx="4688733" cy="3530339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07AE081-D324-406E-FB46-4B7C8BAE2A5A}"/>
              </a:ext>
            </a:extLst>
          </p:cNvPr>
          <p:cNvSpPr txBox="1"/>
          <p:nvPr/>
        </p:nvSpPr>
        <p:spPr>
          <a:xfrm>
            <a:off x="1833113" y="4770956"/>
            <a:ext cx="5776005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799" dirty="0">
                <a:latin typeface="Arial" panose="020B0604020202020204" pitchFamily="34" charset="0"/>
                <a:cs typeface="Arial" panose="020B0604020202020204" pitchFamily="34" charset="0"/>
              </a:rPr>
              <a:t>Control 									        ADP</a:t>
            </a:r>
            <a:endParaRPr lang="ja-JP" altLang="en-US" sz="1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0D47A5B9-B7A8-2C53-C688-CFA7C8CE56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7847" y="5787190"/>
            <a:ext cx="3124636" cy="3943901"/>
          </a:xfrm>
          <a:prstGeom prst="rect">
            <a:avLst/>
          </a:prstGeom>
        </p:spPr>
      </p:pic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FB29CE04-5CFD-B0AB-8FFB-72155B8C20E6}"/>
              </a:ext>
            </a:extLst>
          </p:cNvPr>
          <p:cNvSpPr/>
          <p:nvPr/>
        </p:nvSpPr>
        <p:spPr>
          <a:xfrm>
            <a:off x="390327" y="5553640"/>
            <a:ext cx="3551275" cy="2764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799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A933E6C0-4B2E-8C1E-0508-BF7C87412640}"/>
              </a:ext>
            </a:extLst>
          </p:cNvPr>
          <p:cNvSpPr/>
          <p:nvPr/>
        </p:nvSpPr>
        <p:spPr>
          <a:xfrm>
            <a:off x="307979" y="5681231"/>
            <a:ext cx="1032339" cy="37840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799" dirty="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ACD12D12-1F42-6765-5AE1-B1B465226364}"/>
              </a:ext>
            </a:extLst>
          </p:cNvPr>
          <p:cNvSpPr/>
          <p:nvPr/>
        </p:nvSpPr>
        <p:spPr>
          <a:xfrm>
            <a:off x="497850" y="9316470"/>
            <a:ext cx="179557" cy="6481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799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25DE3017-235E-E6CC-BBAA-6440B97055CD}"/>
              </a:ext>
            </a:extLst>
          </p:cNvPr>
          <p:cNvSpPr/>
          <p:nvPr/>
        </p:nvSpPr>
        <p:spPr>
          <a:xfrm>
            <a:off x="330300" y="9614180"/>
            <a:ext cx="1032339" cy="3504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799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F2F7BB0-24F6-09C7-CD2C-4DDC9809AC58}"/>
              </a:ext>
            </a:extLst>
          </p:cNvPr>
          <p:cNvSpPr txBox="1"/>
          <p:nvPr/>
        </p:nvSpPr>
        <p:spPr>
          <a:xfrm>
            <a:off x="844954" y="5998640"/>
            <a:ext cx="452012" cy="3572645"/>
          </a:xfrm>
          <a:prstGeom prst="rect">
            <a:avLst/>
          </a:prstGeom>
          <a:noFill/>
        </p:spPr>
        <p:txBody>
          <a:bodyPr wrap="none" rIns="18000" rtlCol="0">
            <a:spAutoFit/>
          </a:bodyPr>
          <a:lstStyle/>
          <a:p>
            <a:pPr algn="r">
              <a:lnSpc>
                <a:spcPts val="2100"/>
              </a:lnSpc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2100"/>
              </a:lnSpc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F96C4E0-A2E5-7F71-9C44-F7B1094AA287}"/>
              </a:ext>
            </a:extLst>
          </p:cNvPr>
          <p:cNvSpPr txBox="1"/>
          <p:nvPr/>
        </p:nvSpPr>
        <p:spPr>
          <a:xfrm rot="16200000">
            <a:off x="-32117" y="7478429"/>
            <a:ext cx="16674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ggregation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069919E-23AE-1BE5-460E-6AD0AB3EC532}"/>
              </a:ext>
            </a:extLst>
          </p:cNvPr>
          <p:cNvSpPr txBox="1"/>
          <p:nvPr/>
        </p:nvSpPr>
        <p:spPr>
          <a:xfrm>
            <a:off x="1158316" y="9698877"/>
            <a:ext cx="30547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spc="39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ja-JP" altLang="en-US" sz="1600" spc="39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ja-JP" sz="1600" spc="39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ja-JP" altLang="en-US" sz="1600" spc="39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US" altLang="ja-JP" sz="1600" spc="39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ja-JP" altLang="en-US" sz="1600" spc="39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altLang="ja-JP" sz="1600" spc="39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ja-JP" altLang="en-US" sz="1600" spc="39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altLang="ja-JP" sz="1600" spc="39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r>
              <a:rPr lang="en-US" altLang="ja-JP" sz="1600" spc="39" dirty="0">
                <a:latin typeface="Arial" panose="020B0604020202020204" pitchFamily="34" charset="0"/>
                <a:cs typeface="Arial" panose="020B0604020202020204" pitchFamily="34" charset="0"/>
              </a:rPr>
              <a:t>		Time</a:t>
            </a:r>
            <a:r>
              <a:rPr lang="ja-JP" altLang="en-US" sz="1600" spc="39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spc="39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ja-JP" altLang="en-US" sz="1600" spc="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14DAE4B0-80B4-EAFD-406C-E0A09DCBD13D}"/>
              </a:ext>
            </a:extLst>
          </p:cNvPr>
          <p:cNvCxnSpPr/>
          <p:nvPr/>
        </p:nvCxnSpPr>
        <p:spPr>
          <a:xfrm>
            <a:off x="1698131" y="7047901"/>
            <a:ext cx="0" cy="38660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6533A12-743B-6225-ADD5-8C6CE75037BF}"/>
              </a:ext>
            </a:extLst>
          </p:cNvPr>
          <p:cNvSpPr txBox="1"/>
          <p:nvPr/>
        </p:nvSpPr>
        <p:spPr>
          <a:xfrm>
            <a:off x="1447840" y="6778252"/>
            <a:ext cx="964363" cy="268034"/>
          </a:xfrm>
          <a:prstGeom prst="rect">
            <a:avLst/>
          </a:prstGeom>
          <a:solidFill>
            <a:schemeClr val="bg1"/>
          </a:solidFill>
        </p:spPr>
        <p:txBody>
          <a:bodyPr wrap="none" lIns="18000" tIns="10801" rIns="18000" bIns="10801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DP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EB0872D-3EEE-88F6-035E-E9A2B43321C9}"/>
              </a:ext>
            </a:extLst>
          </p:cNvPr>
          <p:cNvSpPr txBox="1"/>
          <p:nvPr/>
        </p:nvSpPr>
        <p:spPr>
          <a:xfrm>
            <a:off x="8096791" y="12203683"/>
            <a:ext cx="1297150" cy="399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999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ja-JP" altLang="en-US" sz="1999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DB50583-21E9-00F2-32E9-9DAD27F8F863}"/>
              </a:ext>
            </a:extLst>
          </p:cNvPr>
          <p:cNvSpPr txBox="1"/>
          <p:nvPr/>
        </p:nvSpPr>
        <p:spPr>
          <a:xfrm>
            <a:off x="6625" y="831119"/>
            <a:ext cx="3271088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799" dirty="0">
                <a:latin typeface="Arial" panose="020B0604020202020204" pitchFamily="34" charset="0"/>
                <a:cs typeface="Arial" panose="020B0604020202020204" pitchFamily="34" charset="0"/>
              </a:rPr>
              <a:t>(A) CD62P expression (at 8 h)</a:t>
            </a:r>
            <a:endParaRPr lang="ja-JP" altLang="en-US" sz="1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A00CF85-77C3-B8F6-709B-9BA6A2B528B5}"/>
              </a:ext>
            </a:extLst>
          </p:cNvPr>
          <p:cNvSpPr txBox="1"/>
          <p:nvPr/>
        </p:nvSpPr>
        <p:spPr>
          <a:xfrm>
            <a:off x="0" y="5297728"/>
            <a:ext cx="2454583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799" dirty="0">
                <a:latin typeface="Arial" panose="020B0604020202020204" pitchFamily="34" charset="0"/>
                <a:cs typeface="Arial" panose="020B0604020202020204" pitchFamily="34" charset="0"/>
              </a:rPr>
              <a:t>(B) Aggregation</a:t>
            </a:r>
            <a:r>
              <a:rPr lang="ja-JP" altLang="en-US" sz="1799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799" dirty="0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endParaRPr lang="ja-JP" altLang="en-US" sz="1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900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2736D16-5584-F091-869E-0DD98C6A8399}"/>
              </a:ext>
            </a:extLst>
          </p:cNvPr>
          <p:cNvSpPr txBox="1"/>
          <p:nvPr/>
        </p:nvSpPr>
        <p:spPr>
          <a:xfrm>
            <a:off x="0" y="30093"/>
            <a:ext cx="2491388" cy="399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999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kumimoji="1" lang="ja-JP" altLang="en-US" sz="1999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999" b="1" i="1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kumimoji="1" lang="ja-JP" altLang="en-US" sz="1999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7FB60D6-368A-3BD3-1DA0-CABEBD3C5D90}"/>
              </a:ext>
            </a:extLst>
          </p:cNvPr>
          <p:cNvSpPr txBox="1"/>
          <p:nvPr/>
        </p:nvSpPr>
        <p:spPr>
          <a:xfrm>
            <a:off x="55635" y="613108"/>
            <a:ext cx="1743170" cy="399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999" dirty="0">
                <a:latin typeface="Arial" panose="020B0604020202020204" pitchFamily="34" charset="0"/>
                <a:cs typeface="Arial" panose="020B0604020202020204" pitchFamily="34" charset="0"/>
              </a:rPr>
              <a:t>(A) PLT alone</a:t>
            </a:r>
            <a:endParaRPr kumimoji="1" lang="ja-JP" altLang="en-US" sz="19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1D9B1CF-FBD5-9E87-4136-B6E30046578F}"/>
              </a:ext>
            </a:extLst>
          </p:cNvPr>
          <p:cNvSpPr txBox="1"/>
          <p:nvPr/>
        </p:nvSpPr>
        <p:spPr>
          <a:xfrm>
            <a:off x="4940165" y="589627"/>
            <a:ext cx="2990178" cy="399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999" dirty="0">
                <a:latin typeface="Arial" panose="020B0604020202020204" pitchFamily="34" charset="0"/>
                <a:cs typeface="Arial" panose="020B0604020202020204" pitchFamily="34" charset="0"/>
              </a:rPr>
              <a:t>(B) RPC-C2A cells alone</a:t>
            </a:r>
            <a:endParaRPr kumimoji="1" lang="ja-JP" altLang="en-US" sz="19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6DC5CE9-BF9C-DEC3-A904-3789D34128FE}"/>
              </a:ext>
            </a:extLst>
          </p:cNvPr>
          <p:cNvSpPr txBox="1"/>
          <p:nvPr/>
        </p:nvSpPr>
        <p:spPr>
          <a:xfrm>
            <a:off x="130883" y="4617457"/>
            <a:ext cx="3041858" cy="399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999" dirty="0">
                <a:latin typeface="Arial" panose="020B0604020202020204" pitchFamily="34" charset="0"/>
                <a:cs typeface="Arial" panose="020B0604020202020204" pitchFamily="34" charset="0"/>
              </a:rPr>
              <a:t>(C) PLT + RPC-C2A cells</a:t>
            </a:r>
            <a:endParaRPr kumimoji="1" lang="ja-JP" altLang="en-US" sz="19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8088D89A-4E92-80C0-01DB-9F86EE97E9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740"/>
          <a:stretch/>
        </p:blipFill>
        <p:spPr>
          <a:xfrm>
            <a:off x="180980" y="5017439"/>
            <a:ext cx="2183770" cy="3337938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CF1D855F-2C81-B608-CDAB-D9DD69CCBA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312" r="24428"/>
          <a:stretch/>
        </p:blipFill>
        <p:spPr>
          <a:xfrm>
            <a:off x="2477267" y="5017439"/>
            <a:ext cx="2183770" cy="3337938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8155D0D9-212C-5612-CDBC-7723EF57D4C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740"/>
          <a:stretch/>
        </p:blipFill>
        <p:spPr>
          <a:xfrm>
            <a:off x="4940165" y="5017439"/>
            <a:ext cx="2183770" cy="3337938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65C188D0-AB03-61B7-353F-007778A44C0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90" r="34450"/>
          <a:stretch/>
        </p:blipFill>
        <p:spPr>
          <a:xfrm>
            <a:off x="7240901" y="5017440"/>
            <a:ext cx="2179319" cy="3337937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3EDBE4B1-5B6D-AF21-E8A1-9329C65DA74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02" r="15938"/>
          <a:stretch/>
        </p:blipFill>
        <p:spPr>
          <a:xfrm>
            <a:off x="4944614" y="1013089"/>
            <a:ext cx="2183770" cy="3337938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70CAD08E-79BB-2AD0-67A3-B319B884BDB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32" r="44408"/>
          <a:stretch/>
        </p:blipFill>
        <p:spPr>
          <a:xfrm>
            <a:off x="7240901" y="1013089"/>
            <a:ext cx="2183770" cy="3337938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A287D0E-1932-D9E3-FE24-F19BDDC25AE6}"/>
              </a:ext>
            </a:extLst>
          </p:cNvPr>
          <p:cNvSpPr txBox="1"/>
          <p:nvPr/>
        </p:nvSpPr>
        <p:spPr>
          <a:xfrm>
            <a:off x="3839592" y="7920879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3F037F3-F70E-0EE0-D597-BB344A038172}"/>
              </a:ext>
            </a:extLst>
          </p:cNvPr>
          <p:cNvSpPr txBox="1"/>
          <p:nvPr/>
        </p:nvSpPr>
        <p:spPr>
          <a:xfrm>
            <a:off x="4888485" y="4617457"/>
            <a:ext cx="3840603" cy="399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999" dirty="0">
                <a:latin typeface="Arial" panose="020B0604020202020204" pitchFamily="34" charset="0"/>
                <a:cs typeface="Arial" panose="020B0604020202020204" pitchFamily="34" charset="0"/>
              </a:rPr>
              <a:t>(D) ADP + PLT + RPC-C2A cells</a:t>
            </a:r>
            <a:endParaRPr kumimoji="1" lang="ja-JP" altLang="en-US" sz="19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7DD342B-4251-87C9-A9ED-9D1DB732A5CD}"/>
              </a:ext>
            </a:extLst>
          </p:cNvPr>
          <p:cNvSpPr txBox="1"/>
          <p:nvPr/>
        </p:nvSpPr>
        <p:spPr>
          <a:xfrm>
            <a:off x="336622" y="8402944"/>
            <a:ext cx="9212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ow magnification     High magnification          Low magnification       High magnifica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EB691622-8FF6-350F-DC6B-F9BD0D40FAFC}"/>
              </a:ext>
            </a:extLst>
          </p:cNvPr>
          <p:cNvCxnSpPr>
            <a:cxnSpLocks/>
          </p:cNvCxnSpPr>
          <p:nvPr/>
        </p:nvCxnSpPr>
        <p:spPr>
          <a:xfrm>
            <a:off x="1583069" y="8244050"/>
            <a:ext cx="6667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7310B7E-BE9C-FECE-ABCE-D1B4EC9B814D}"/>
              </a:ext>
            </a:extLst>
          </p:cNvPr>
          <p:cNvSpPr txBox="1"/>
          <p:nvPr/>
        </p:nvSpPr>
        <p:spPr>
          <a:xfrm>
            <a:off x="1583069" y="7932347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kumimoji="1"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C0201614-C43D-AFBD-7391-A61AF59A0B1B}"/>
              </a:ext>
            </a:extLst>
          </p:cNvPr>
          <p:cNvCxnSpPr>
            <a:cxnSpLocks/>
          </p:cNvCxnSpPr>
          <p:nvPr/>
        </p:nvCxnSpPr>
        <p:spPr>
          <a:xfrm>
            <a:off x="3836084" y="8221662"/>
            <a:ext cx="74203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図 6">
            <a:extLst>
              <a:ext uri="{FF2B5EF4-FFF2-40B4-BE49-F238E27FC236}">
                <a16:creationId xmlns:a16="http://schemas.microsoft.com/office/drawing/2014/main" id="{F518F556-E0E5-9530-9C6B-961A40BE899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841"/>
          <a:stretch/>
        </p:blipFill>
        <p:spPr>
          <a:xfrm>
            <a:off x="176529" y="1013089"/>
            <a:ext cx="2179320" cy="333793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24013DC-C2D2-A776-AE59-6939EB76106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250"/>
          <a:stretch/>
        </p:blipFill>
        <p:spPr>
          <a:xfrm>
            <a:off x="2406768" y="1013089"/>
            <a:ext cx="2249819" cy="3337938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7BD7D85-4818-0CE1-68FA-6A50E7DB6514}"/>
              </a:ext>
            </a:extLst>
          </p:cNvPr>
          <p:cNvSpPr txBox="1"/>
          <p:nvPr/>
        </p:nvSpPr>
        <p:spPr>
          <a:xfrm>
            <a:off x="8123070" y="12207239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kumimoji="1" lang="ja-JP" altLang="en-US" sz="2000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8965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</TotalTime>
  <Words>97</Words>
  <Application>Microsoft Office PowerPoint</Application>
  <PresentationFormat>A3 297x420 mm</PresentationFormat>
  <Paragraphs>3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. Kawase</dc:creator>
  <cp:lastModifiedBy>T. Kawase</cp:lastModifiedBy>
  <cp:revision>2</cp:revision>
  <dcterms:created xsi:type="dcterms:W3CDTF">2025-06-07T22:26:36Z</dcterms:created>
  <dcterms:modified xsi:type="dcterms:W3CDTF">2025-06-07T23:18:14Z</dcterms:modified>
</cp:coreProperties>
</file>